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06" r:id="rId2"/>
    <p:sldId id="307" r:id="rId3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52" autoAdjust="0"/>
    <p:restoredTop sz="96247" autoAdjust="0"/>
  </p:normalViewPr>
  <p:slideViewPr>
    <p:cSldViewPr snapToGrid="0">
      <p:cViewPr varScale="1">
        <p:scale>
          <a:sx n="77" d="100"/>
          <a:sy n="77" d="100"/>
        </p:scale>
        <p:origin x="351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37FEF0-7CAB-432B-A1C8-95A08DA7ECAE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734DF-5F11-4274-A00D-0BA1A80B1E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7102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305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0479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763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911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990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593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10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463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0005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052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722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4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06B5678-4F62-4AE7-87CE-213B4DFF94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75529"/>
            <a:ext cx="6701589" cy="3577681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2083AD1-AC2B-4DF7-9ADD-F84DEE6015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411" y="4637912"/>
            <a:ext cx="6545178" cy="3813193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82B4788F-C415-45CB-97D9-6F4CF0AD7F65}"/>
              </a:ext>
            </a:extLst>
          </p:cNvPr>
          <p:cNvSpPr txBox="1"/>
          <p:nvPr/>
        </p:nvSpPr>
        <p:spPr>
          <a:xfrm>
            <a:off x="156411" y="213828"/>
            <a:ext cx="2101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4D84486-FEDA-4281-BFC8-6BD6608F59DE}"/>
              </a:ext>
            </a:extLst>
          </p:cNvPr>
          <p:cNvSpPr txBox="1"/>
          <p:nvPr/>
        </p:nvSpPr>
        <p:spPr>
          <a:xfrm>
            <a:off x="156411" y="498530"/>
            <a:ext cx="1457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DB6D762-394C-48CA-907B-9F6D92983B29}"/>
              </a:ext>
            </a:extLst>
          </p:cNvPr>
          <p:cNvSpPr txBox="1"/>
          <p:nvPr/>
        </p:nvSpPr>
        <p:spPr>
          <a:xfrm>
            <a:off x="61558" y="4499412"/>
            <a:ext cx="1457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796235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0A956F1-5B8C-446D-A4F2-20DF814B536C}"/>
              </a:ext>
            </a:extLst>
          </p:cNvPr>
          <p:cNvSpPr/>
          <p:nvPr/>
        </p:nvSpPr>
        <p:spPr>
          <a:xfrm>
            <a:off x="180473" y="689628"/>
            <a:ext cx="6509085" cy="41033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Mice were injected intravenously (iv) with 0.05 mg/mouse SDC4 antibody (100µl). After 18 min of incubation, cardiac perfusion with Ringer was performed to flush out unbound antibody. Kidney was snap frozen for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fluorescenc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taining. (A) Frozen kidney sections were incubated with secondary antibody to SDC4 ( Alexa 488, green) and DAPI (blue). Representative images show that the SDC4 antibody localised predominantly to the glomeruli in the SDC4 injected mice and no SDC4 staini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an be seen i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he PBS injected mice.(B) Frozen kidney sections from SDC4 antibody (red and green) injected mice were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staine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with CD31 (endothelial, green), podocin (podocytes, red) and DAPI (blue). Representative confocal images show SDC4 colocalises predominantly with endothelial and not podocyte markers.</a:t>
            </a:r>
          </a:p>
          <a:p>
            <a:pPr>
              <a:lnSpc>
                <a:spcPct val="200000"/>
              </a:lnSpc>
            </a:pPr>
            <a:endParaRPr lang="en-GB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211956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766</TotalTime>
  <Words>153</Words>
  <Application>Microsoft Office PowerPoint</Application>
  <PresentationFormat>A4 Paper (210x297 mm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a Ramnath</dc:creator>
  <cp:lastModifiedBy>Raina Ramnath</cp:lastModifiedBy>
  <cp:revision>661</cp:revision>
  <cp:lastPrinted>2018-11-05T10:42:07Z</cp:lastPrinted>
  <dcterms:created xsi:type="dcterms:W3CDTF">2018-02-07T14:08:32Z</dcterms:created>
  <dcterms:modified xsi:type="dcterms:W3CDTF">2019-09-05T13:50:14Z</dcterms:modified>
</cp:coreProperties>
</file>